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068907-087C-49FE-BCBF-1211F70547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382D6-8E01-44F4-B947-11D1B80B3B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942A9A-092C-4335-AC90-3B29489C18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C59EB3-F91C-4CE5-A498-734D3D5F60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4AFE1-11D5-45D0-BB44-A6643A2BFD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372DCC-2D76-4776-BEDC-3F92829F10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889271-BE06-4DC7-A76E-1D577C2AE1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68FAEF-EC5F-4E26-98CD-DE7317E76C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EF4A2E-249B-4E5F-8833-461CABEACE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272A45-1EA4-452B-9529-97733B8E1D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766BE7-357C-43FF-89AC-5BBE1591DA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ECE14E-B3BA-4895-81FF-B1691B0C61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6C0060-5991-4AFE-B202-EBE2084BC4C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9903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just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 Figure 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Representative examples of Receiver-operator characteristic (ROC) curves,  generated to create optimal cutoffs to maximize sensitivity and specificity on the comparison of two sample types. The ROC curves plot sensitivity versus 100% - Specificity (1- Specificity). (A) ROC curve considering non-seminoma  samples (14)  and normal samples (23). This ROC illustrates the predictive power of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R-</a:t>
            </a:r>
            <a:r>
              <a:rPr b="0" i="1" lang="el-GR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lone (with area under the curve – AUC- of 0.62); (B) ROC curve considering all testicular cancer (TGTC) samples (57)  and normal samples (23). This ROC illustrates the predictive power of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CAM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lone (with area under the curve – AUC- of 0.53); (C) ROC curve considering TGTC samples (57)  and normal samples (23). This ROC illustrates the predictive power of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hMLH1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lone (with area under the curve – AUC- of 0.67) 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CaixaDeTexto 5"/>
          <p:cNvSpPr/>
          <p:nvPr/>
        </p:nvSpPr>
        <p:spPr>
          <a:xfrm>
            <a:off x="480600" y="2971800"/>
            <a:ext cx="42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CaixaDeTexto 6"/>
          <p:cNvSpPr/>
          <p:nvPr/>
        </p:nvSpPr>
        <p:spPr>
          <a:xfrm>
            <a:off x="3309480" y="2971800"/>
            <a:ext cx="420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5" descr=""/>
          <p:cNvPicPr/>
          <p:nvPr/>
        </p:nvPicPr>
        <p:blipFill>
          <a:blip r:embed="rId1"/>
          <a:stretch/>
        </p:blipFill>
        <p:spPr>
          <a:xfrm>
            <a:off x="457200" y="3467160"/>
            <a:ext cx="2830680" cy="23241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6" descr=""/>
          <p:cNvPicPr/>
          <p:nvPr/>
        </p:nvPicPr>
        <p:blipFill>
          <a:blip r:embed="rId2"/>
          <a:stretch/>
        </p:blipFill>
        <p:spPr>
          <a:xfrm>
            <a:off x="3200400" y="3390840"/>
            <a:ext cx="2905200" cy="237492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7" descr=""/>
          <p:cNvPicPr/>
          <p:nvPr/>
        </p:nvPicPr>
        <p:blipFill>
          <a:blip r:embed="rId3"/>
          <a:stretch/>
        </p:blipFill>
        <p:spPr>
          <a:xfrm>
            <a:off x="6195960" y="3429000"/>
            <a:ext cx="2795760" cy="2286000"/>
          </a:xfrm>
          <a:prstGeom prst="rect">
            <a:avLst/>
          </a:prstGeom>
          <a:ln w="0">
            <a:noFill/>
          </a:ln>
        </p:spPr>
      </p:pic>
      <p:sp>
        <p:nvSpPr>
          <p:cNvPr id="47" name="CaixaDeTexto 11"/>
          <p:cNvSpPr/>
          <p:nvPr/>
        </p:nvSpPr>
        <p:spPr>
          <a:xfrm>
            <a:off x="6358320" y="2971800"/>
            <a:ext cx="412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(C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just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 Figure 2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Receiver-operator characteristic (ROC) curves considering non-seminoma  samples (14)  and the normal samples (23) .The ROC curves plot sensitivity versus 1-speciﬁcity (100%- specificity). This ROC illustrates the predictive power of hMLH1 alone (with area under the curve – AUC- of 0.84) as well as combination with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PC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R-Beta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UC = 0.89)</a:t>
            </a:r>
            <a:r>
              <a:rPr b="0" i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10" descr=""/>
          <p:cNvPicPr/>
          <p:nvPr/>
        </p:nvPicPr>
        <p:blipFill>
          <a:blip r:embed="rId1"/>
          <a:srcRect l="0" t="8488" r="0" b="0"/>
          <a:stretch/>
        </p:blipFill>
        <p:spPr>
          <a:xfrm>
            <a:off x="1676520" y="1828800"/>
            <a:ext cx="5705280" cy="4724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15T17:44:25Z</dcterms:created>
  <dc:creator>MARIANA BRAIT</dc:creator>
  <dc:description/>
  <dc:language>en-US</dc:language>
  <cp:lastModifiedBy>MARIANA BRAIT</cp:lastModifiedBy>
  <dcterms:modified xsi:type="dcterms:W3CDTF">2011-09-27T15:57:58Z</dcterms:modified>
  <cp:revision>10</cp:revision>
  <dc:subject/>
  <dc:title>Supplemental  Figure 1. Receiver-operator characteristic (ROC) curves considering non-seminoma samples (14)  and the normal samples (23) .The ROC curves plot sensitivity versus 1-speciﬁcity. This ROC illustrates the predictive power of hMLH1 alone (with area under the curve – AUC- of 0.84) as well as combination with APC and ER-Beta (AUC = 0.89).</dc:title>
</cp:coreProperties>
</file>